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06" d="100"/>
          <a:sy n="106" d="100"/>
        </p:scale>
        <p:origin x="1026" y="-35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88BB7-5717-41F5-B945-5F15A8F6AE25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FDC06-F7C8-4042-AAF4-715DEDE4D8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065771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88BB7-5717-41F5-B945-5F15A8F6AE25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FDC06-F7C8-4042-AAF4-715DEDE4D8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502525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88BB7-5717-41F5-B945-5F15A8F6AE25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FDC06-F7C8-4042-AAF4-715DEDE4D8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89781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88BB7-5717-41F5-B945-5F15A8F6AE25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FDC06-F7C8-4042-AAF4-715DEDE4D8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27527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88BB7-5717-41F5-B945-5F15A8F6AE25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FDC06-F7C8-4042-AAF4-715DEDE4D8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20304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88BB7-5717-41F5-B945-5F15A8F6AE25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FDC06-F7C8-4042-AAF4-715DEDE4D8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703424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88BB7-5717-41F5-B945-5F15A8F6AE25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FDC06-F7C8-4042-AAF4-715DEDE4D8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81808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88BB7-5717-41F5-B945-5F15A8F6AE25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FDC06-F7C8-4042-AAF4-715DEDE4D8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313026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88BB7-5717-41F5-B945-5F15A8F6AE25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FDC06-F7C8-4042-AAF4-715DEDE4D8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661324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88BB7-5717-41F5-B945-5F15A8F6AE25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FDC06-F7C8-4042-AAF4-715DEDE4D8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555802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88BB7-5717-41F5-B945-5F15A8F6AE25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FDC06-F7C8-4042-AAF4-715DEDE4D8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747825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188BB7-5717-41F5-B945-5F15A8F6AE25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3FDC06-F7C8-4042-AAF4-715DEDE4D8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118953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e 16"/>
          <p:cNvGrpSpPr/>
          <p:nvPr/>
        </p:nvGrpSpPr>
        <p:grpSpPr>
          <a:xfrm>
            <a:off x="0" y="0"/>
            <a:ext cx="6315005" cy="8822791"/>
            <a:chOff x="0" y="0"/>
            <a:chExt cx="6315005" cy="8822791"/>
          </a:xfrm>
        </p:grpSpPr>
        <p:pic>
          <p:nvPicPr>
            <p:cNvPr id="2" name="Image 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67753" y="6943803"/>
              <a:ext cx="2147252" cy="1878988"/>
            </a:xfrm>
            <a:prstGeom prst="rect">
              <a:avLst/>
            </a:prstGeom>
          </p:spPr>
        </p:pic>
        <p:pic>
          <p:nvPicPr>
            <p:cNvPr id="3" name="Image 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0"/>
              <a:ext cx="2147252" cy="1878988"/>
            </a:xfrm>
            <a:prstGeom prst="rect">
              <a:avLst/>
            </a:prstGeom>
          </p:spPr>
        </p:pic>
        <p:pic>
          <p:nvPicPr>
            <p:cNvPr id="4" name="Image 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93204" y="0"/>
              <a:ext cx="2147252" cy="1878988"/>
            </a:xfrm>
            <a:prstGeom prst="rect">
              <a:avLst/>
            </a:prstGeom>
          </p:spPr>
        </p:pic>
        <p:pic>
          <p:nvPicPr>
            <p:cNvPr id="5" name="Image 4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67753" y="0"/>
              <a:ext cx="2147252" cy="1878988"/>
            </a:xfrm>
            <a:prstGeom prst="rect">
              <a:avLst/>
            </a:prstGeom>
          </p:spPr>
        </p:pic>
        <p:pic>
          <p:nvPicPr>
            <p:cNvPr id="6" name="Image 5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1767994"/>
              <a:ext cx="2147252" cy="1878988"/>
            </a:xfrm>
            <a:prstGeom prst="rect">
              <a:avLst/>
            </a:prstGeom>
          </p:spPr>
        </p:pic>
        <p:pic>
          <p:nvPicPr>
            <p:cNvPr id="7" name="Image 6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93204" y="1767994"/>
              <a:ext cx="2147252" cy="1878988"/>
            </a:xfrm>
            <a:prstGeom prst="rect">
              <a:avLst/>
            </a:prstGeom>
          </p:spPr>
        </p:pic>
        <p:pic>
          <p:nvPicPr>
            <p:cNvPr id="8" name="Image 7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67753" y="1767994"/>
              <a:ext cx="2147252" cy="1878988"/>
            </a:xfrm>
            <a:prstGeom prst="rect">
              <a:avLst/>
            </a:prstGeom>
          </p:spPr>
        </p:pic>
        <p:pic>
          <p:nvPicPr>
            <p:cNvPr id="9" name="Image 8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3293681"/>
              <a:ext cx="2147252" cy="1878988"/>
            </a:xfrm>
            <a:prstGeom prst="rect">
              <a:avLst/>
            </a:prstGeom>
          </p:spPr>
        </p:pic>
        <p:pic>
          <p:nvPicPr>
            <p:cNvPr id="10" name="Image 9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93204" y="3293681"/>
              <a:ext cx="2147252" cy="1878988"/>
            </a:xfrm>
            <a:prstGeom prst="rect">
              <a:avLst/>
            </a:prstGeom>
          </p:spPr>
        </p:pic>
        <p:pic>
          <p:nvPicPr>
            <p:cNvPr id="11" name="Image 10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67753" y="3293681"/>
              <a:ext cx="2147252" cy="1878988"/>
            </a:xfrm>
            <a:prstGeom prst="rect">
              <a:avLst/>
            </a:prstGeom>
          </p:spPr>
        </p:pic>
        <p:pic>
          <p:nvPicPr>
            <p:cNvPr id="12" name="Image 11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5165308"/>
              <a:ext cx="2147252" cy="1878988"/>
            </a:xfrm>
            <a:prstGeom prst="rect">
              <a:avLst/>
            </a:prstGeom>
          </p:spPr>
        </p:pic>
        <p:pic>
          <p:nvPicPr>
            <p:cNvPr id="13" name="Image 12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93204" y="5165308"/>
              <a:ext cx="2147252" cy="1878988"/>
            </a:xfrm>
            <a:prstGeom prst="rect">
              <a:avLst/>
            </a:prstGeom>
          </p:spPr>
        </p:pic>
        <p:pic>
          <p:nvPicPr>
            <p:cNvPr id="14" name="Image 13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93204" y="6943803"/>
              <a:ext cx="2147252" cy="1878988"/>
            </a:xfrm>
            <a:prstGeom prst="rect">
              <a:avLst/>
            </a:prstGeom>
          </p:spPr>
        </p:pic>
        <p:pic>
          <p:nvPicPr>
            <p:cNvPr id="15" name="Image 14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703" y="6943803"/>
              <a:ext cx="2147252" cy="1878988"/>
            </a:xfrm>
            <a:prstGeom prst="rect">
              <a:avLst/>
            </a:prstGeom>
          </p:spPr>
        </p:pic>
        <p:pic>
          <p:nvPicPr>
            <p:cNvPr id="16" name="Image 15"/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30" t="11520" r="4759" b="6282"/>
            <a:stretch/>
          </p:blipFill>
          <p:spPr>
            <a:xfrm>
              <a:off x="4240456" y="5442439"/>
              <a:ext cx="1967114" cy="1544491"/>
            </a:xfrm>
            <a:prstGeom prst="rect">
              <a:avLst/>
            </a:prstGeom>
            <a:solidFill>
              <a:srgbClr val="FFFFFF">
                <a:shade val="85000"/>
              </a:srgbClr>
            </a:solidFill>
            <a:ln w="190500" cap="rnd">
              <a:noFill/>
            </a:ln>
            <a:effectLst>
              <a:outerShdw blurRad="50000" algn="tl" rotWithShape="0">
                <a:srgbClr val="000000">
                  <a:alpha val="41000"/>
                </a:srgbClr>
              </a:outerShdw>
            </a:effectLst>
            <a:scene3d>
              <a:camera prst="orthographicFront"/>
              <a:lightRig rig="twoPt" dir="t">
                <a:rot lat="0" lon="0" rev="7800000"/>
              </a:lightRig>
            </a:scene3d>
            <a:sp3d contourW="6350">
              <a:bevelT w="50800" h="16510"/>
              <a:contourClr>
                <a:srgbClr val="C0C0C0"/>
              </a:contourClr>
            </a:sp3d>
          </p:spPr>
        </p:pic>
      </p:grpSp>
      <p:sp>
        <p:nvSpPr>
          <p:cNvPr id="20" name="Rectangle 19">
            <a:extLst>
              <a:ext uri="{FF2B5EF4-FFF2-40B4-BE49-F238E27FC236}">
                <a16:creationId xmlns:a16="http://schemas.microsoft.com/office/drawing/2014/main" id="{E63E60CF-2093-4AFC-9CD0-262ED2CC249E}"/>
              </a:ext>
            </a:extLst>
          </p:cNvPr>
          <p:cNvSpPr/>
          <p:nvPr/>
        </p:nvSpPr>
        <p:spPr>
          <a:xfrm>
            <a:off x="147387" y="8857798"/>
            <a:ext cx="6563226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Figure </a:t>
            </a:r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: 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Quantification of soluble </a:t>
            </a:r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amino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acids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as percentage of total </a:t>
            </a:r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amino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content in </a:t>
            </a:r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barley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leaves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under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HN. 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Plants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harveste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after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4 </a:t>
            </a:r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owing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llowing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freezing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liqui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nitrogen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AA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quantified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PLC 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as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indicate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Material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method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different letters indicate values significantly different at P &lt;0.05 as determined using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 -ANOVA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ewman–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Keul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SNK)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omparisons.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317986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4</TotalTime>
  <Words>71</Words>
  <Application>Microsoft Office PowerPoint</Application>
  <PresentationFormat>Format A4 (210 x 297 mm)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ia Dellagi</dc:creator>
  <cp:lastModifiedBy>Alia Dellagi</cp:lastModifiedBy>
  <cp:revision>12</cp:revision>
  <cp:lastPrinted>2021-04-15T20:04:17Z</cp:lastPrinted>
  <dcterms:created xsi:type="dcterms:W3CDTF">2021-04-13T15:53:32Z</dcterms:created>
  <dcterms:modified xsi:type="dcterms:W3CDTF">2021-11-01T17:03:55Z</dcterms:modified>
</cp:coreProperties>
</file>